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452" y="22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F8156-CA4B-4885-848D-F3C60C4D84F5}" type="datetimeFigureOut">
              <a:rPr lang="en-GB" smtClean="0"/>
              <a:t>04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B4E8D-6F73-4CA4-B83E-D03491748FBF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F8156-CA4B-4885-848D-F3C60C4D84F5}" type="datetimeFigureOut">
              <a:rPr lang="en-GB" smtClean="0"/>
              <a:t>04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B4E8D-6F73-4CA4-B83E-D03491748FBF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F8156-CA4B-4885-848D-F3C60C4D84F5}" type="datetimeFigureOut">
              <a:rPr lang="en-GB" smtClean="0"/>
              <a:t>04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B4E8D-6F73-4CA4-B83E-D03491748FBF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F8156-CA4B-4885-848D-F3C60C4D84F5}" type="datetimeFigureOut">
              <a:rPr lang="en-GB" smtClean="0"/>
              <a:t>04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B4E8D-6F73-4CA4-B83E-D03491748FBF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F8156-CA4B-4885-848D-F3C60C4D84F5}" type="datetimeFigureOut">
              <a:rPr lang="en-GB" smtClean="0"/>
              <a:t>04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B4E8D-6F73-4CA4-B83E-D03491748FBF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F8156-CA4B-4885-848D-F3C60C4D84F5}" type="datetimeFigureOut">
              <a:rPr lang="en-GB" smtClean="0"/>
              <a:t>04/1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B4E8D-6F73-4CA4-B83E-D03491748FBF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F8156-CA4B-4885-848D-F3C60C4D84F5}" type="datetimeFigureOut">
              <a:rPr lang="en-GB" smtClean="0"/>
              <a:t>04/11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B4E8D-6F73-4CA4-B83E-D03491748FBF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F8156-CA4B-4885-848D-F3C60C4D84F5}" type="datetimeFigureOut">
              <a:rPr lang="en-GB" smtClean="0"/>
              <a:t>04/11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B4E8D-6F73-4CA4-B83E-D03491748FBF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F8156-CA4B-4885-848D-F3C60C4D84F5}" type="datetimeFigureOut">
              <a:rPr lang="en-GB" smtClean="0"/>
              <a:t>04/11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B4E8D-6F73-4CA4-B83E-D03491748FBF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F8156-CA4B-4885-848D-F3C60C4D84F5}" type="datetimeFigureOut">
              <a:rPr lang="en-GB" smtClean="0"/>
              <a:t>04/1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B4E8D-6F73-4CA4-B83E-D03491748FBF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8F8156-CA4B-4885-848D-F3C60C4D84F5}" type="datetimeFigureOut">
              <a:rPr lang="en-GB" smtClean="0"/>
              <a:t>04/11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B4E8D-6F73-4CA4-B83E-D03491748FBF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8F8156-CA4B-4885-848D-F3C60C4D84F5}" type="datetimeFigureOut">
              <a:rPr lang="en-GB" smtClean="0"/>
              <a:t>04/11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2B4E8D-6F73-4CA4-B83E-D03491748FBF}" type="slidenum">
              <a:rPr lang="en-GB" smtClean="0"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579864" y="1259632"/>
            <a:ext cx="5945480" cy="4695804"/>
            <a:chOff x="579864" y="1259632"/>
            <a:chExt cx="5945480" cy="4695804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779" t="17143" r="19643" b="10095"/>
            <a:stretch/>
          </p:blipFill>
          <p:spPr bwMode="auto">
            <a:xfrm>
              <a:off x="579864" y="1259632"/>
              <a:ext cx="5945480" cy="46958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" name="Up Arrow 5"/>
            <p:cNvSpPr/>
            <p:nvPr/>
          </p:nvSpPr>
          <p:spPr>
            <a:xfrm>
              <a:off x="5062498" y="2017600"/>
              <a:ext cx="36000" cy="144016"/>
            </a:xfrm>
            <a:prstGeom prst="upArrow">
              <a:avLst/>
            </a:prstGeom>
            <a:ln w="3175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" name="Up Arrow 6"/>
            <p:cNvSpPr/>
            <p:nvPr/>
          </p:nvSpPr>
          <p:spPr>
            <a:xfrm>
              <a:off x="5139111" y="2017600"/>
              <a:ext cx="36000" cy="144016"/>
            </a:xfrm>
            <a:prstGeom prst="upArrow">
              <a:avLst/>
            </a:prstGeom>
            <a:ln w="3175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" name="Up Arrow 7"/>
            <p:cNvSpPr/>
            <p:nvPr/>
          </p:nvSpPr>
          <p:spPr>
            <a:xfrm>
              <a:off x="5215724" y="2017600"/>
              <a:ext cx="36000" cy="144016"/>
            </a:xfrm>
            <a:prstGeom prst="upArrow">
              <a:avLst/>
            </a:prstGeom>
            <a:ln w="3175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" name="Up Arrow 8"/>
            <p:cNvSpPr/>
            <p:nvPr/>
          </p:nvSpPr>
          <p:spPr>
            <a:xfrm>
              <a:off x="5292336" y="2017600"/>
              <a:ext cx="36000" cy="144016"/>
            </a:xfrm>
            <a:prstGeom prst="upArrow">
              <a:avLst/>
            </a:prstGeom>
            <a:ln w="3175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" name="Up Arrow 10"/>
            <p:cNvSpPr/>
            <p:nvPr/>
          </p:nvSpPr>
          <p:spPr>
            <a:xfrm>
              <a:off x="4488192" y="3203848"/>
              <a:ext cx="36000" cy="144016"/>
            </a:xfrm>
            <a:prstGeom prst="upArrow">
              <a:avLst/>
            </a:prstGeom>
            <a:ln w="3175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" name="Up Arrow 11"/>
            <p:cNvSpPr/>
            <p:nvPr/>
          </p:nvSpPr>
          <p:spPr>
            <a:xfrm>
              <a:off x="4777982" y="3203848"/>
              <a:ext cx="36000" cy="144016"/>
            </a:xfrm>
            <a:prstGeom prst="upArrow">
              <a:avLst/>
            </a:prstGeom>
            <a:ln w="3175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" name="Up Arrow 12"/>
            <p:cNvSpPr/>
            <p:nvPr/>
          </p:nvSpPr>
          <p:spPr>
            <a:xfrm>
              <a:off x="4705634" y="3203848"/>
              <a:ext cx="36000" cy="144016"/>
            </a:xfrm>
            <a:prstGeom prst="upArrow">
              <a:avLst/>
            </a:prstGeom>
            <a:ln w="3175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" name="Up Arrow 13"/>
            <p:cNvSpPr/>
            <p:nvPr/>
          </p:nvSpPr>
          <p:spPr>
            <a:xfrm>
              <a:off x="5068354" y="3203848"/>
              <a:ext cx="36000" cy="144016"/>
            </a:xfrm>
            <a:prstGeom prst="upArrow">
              <a:avLst/>
            </a:prstGeom>
            <a:ln w="3175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" name="Up Arrow 14"/>
            <p:cNvSpPr/>
            <p:nvPr/>
          </p:nvSpPr>
          <p:spPr>
            <a:xfrm>
              <a:off x="3750692" y="4394324"/>
              <a:ext cx="36000" cy="144016"/>
            </a:xfrm>
            <a:prstGeom prst="upArrow">
              <a:avLst/>
            </a:prstGeom>
            <a:ln w="3175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" name="Up Arrow 15"/>
            <p:cNvSpPr/>
            <p:nvPr/>
          </p:nvSpPr>
          <p:spPr>
            <a:xfrm>
              <a:off x="3832596" y="4395809"/>
              <a:ext cx="36000" cy="144016"/>
            </a:xfrm>
            <a:prstGeom prst="upArrow">
              <a:avLst/>
            </a:prstGeom>
            <a:ln w="3175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" name="Up Arrow 16"/>
            <p:cNvSpPr/>
            <p:nvPr/>
          </p:nvSpPr>
          <p:spPr>
            <a:xfrm>
              <a:off x="2209002" y="4390186"/>
              <a:ext cx="36000" cy="144016"/>
            </a:xfrm>
            <a:prstGeom prst="upArrow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GB">
                <a:ln>
                  <a:solidFill>
                    <a:schemeClr val="bg1"/>
                  </a:solidFill>
                </a:ln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2781032" y="6124993"/>
            <a:ext cx="1543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Figure S1</a:t>
            </a:r>
            <a:endParaRPr lang="en-GB" dirty="0"/>
          </a:p>
        </p:txBody>
      </p:sp>
      <p:sp>
        <p:nvSpPr>
          <p:cNvPr id="3" name="TextBox 2"/>
          <p:cNvSpPr txBox="1"/>
          <p:nvPr/>
        </p:nvSpPr>
        <p:spPr>
          <a:xfrm>
            <a:off x="486720" y="6804248"/>
            <a:ext cx="5760639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smtClean="0"/>
              <a:t>Figure </a:t>
            </a:r>
            <a:r>
              <a:rPr lang="en-US" b="1" dirty="0"/>
              <a:t>S1. Sequence alignment of typical 2-cys </a:t>
            </a:r>
            <a:r>
              <a:rPr lang="en-US" b="1" dirty="0" err="1"/>
              <a:t>Prxs</a:t>
            </a:r>
            <a:endParaRPr lang="en-GB" dirty="0"/>
          </a:p>
          <a:p>
            <a:r>
              <a:rPr lang="en-US" b="1" dirty="0"/>
              <a:t> </a:t>
            </a:r>
            <a:endParaRPr lang="en-GB" dirty="0"/>
          </a:p>
          <a:p>
            <a:r>
              <a:rPr lang="en-US" dirty="0"/>
              <a:t>Sequence alignment of human </a:t>
            </a:r>
            <a:r>
              <a:rPr lang="en-US" dirty="0" err="1"/>
              <a:t>PrxI</a:t>
            </a:r>
            <a:r>
              <a:rPr lang="en-US" dirty="0"/>
              <a:t> to PrxIV and bovine PrxIII showing difference between </a:t>
            </a:r>
            <a:r>
              <a:rPr lang="en-US" dirty="0" err="1"/>
              <a:t>Prxs</a:t>
            </a:r>
            <a:r>
              <a:rPr lang="en-US" dirty="0"/>
              <a:t> . Black arrows indicate the residues involved in bovine PrxIII ring </a:t>
            </a:r>
            <a:r>
              <a:rPr lang="en-US" dirty="0" err="1"/>
              <a:t>ring</a:t>
            </a:r>
            <a:r>
              <a:rPr lang="en-US" dirty="0"/>
              <a:t> interactions.</a:t>
            </a:r>
            <a:endParaRPr lang="en-GB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591780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11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install</dc:creator>
  <cp:lastModifiedBy>Zhenbo Cao</cp:lastModifiedBy>
  <cp:revision>7</cp:revision>
  <dcterms:created xsi:type="dcterms:W3CDTF">2011-12-02T14:53:04Z</dcterms:created>
  <dcterms:modified xsi:type="dcterms:W3CDTF">2014-11-04T16:51:43Z</dcterms:modified>
</cp:coreProperties>
</file>